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8" r:id="rId2"/>
  </p:sldIdLst>
  <p:sldSz cx="6858000" cy="9144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35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9441"/>
    <p:restoredTop sz="94522"/>
  </p:normalViewPr>
  <p:slideViewPr>
    <p:cSldViewPr>
      <p:cViewPr>
        <p:scale>
          <a:sx n="150" d="100"/>
          <a:sy n="150" d="100"/>
        </p:scale>
        <p:origin x="72" y="2226"/>
      </p:cViewPr>
      <p:guideLst>
        <p:guide orient="horz" pos="283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9DE63A-05F3-4ED0-BEE9-4217A22E0FC5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64386A-5E62-4B7F-8466-F9386CEA9FF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84861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961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1691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8989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5730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1843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8604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0874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5939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0735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7148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3503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3293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4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3.jpeg"/><Relationship Id="rId10" Type="http://schemas.openxmlformats.org/officeDocument/2006/relationships/image" Target="../media/image6.jpeg"/><Relationship Id="rId4" Type="http://schemas.openxmlformats.org/officeDocument/2006/relationships/image" Target="../media/image2.jpeg"/><Relationship Id="rId9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20"/>
          <p:cNvSpPr txBox="1"/>
          <p:nvPr/>
        </p:nvSpPr>
        <p:spPr>
          <a:xfrm>
            <a:off x="53416" y="3186425"/>
            <a:ext cx="546381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6 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orphological evaluation of the colonies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: B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urs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forming unit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erythroi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BFU-E), B: Colony-forming unit-granulocyte/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erythroi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egakaryocyt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onocyt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(CFU-GEMM)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: Colony-forming unit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erythroi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CFU-E) , D: Colony-forming unit-macrophage (CFU-M)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: Colony-forming unit-granulocyte (CFU-G),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F: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olony-forming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nit-granulocyt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acrophag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(CFU-GM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mages were examined using a Zeiss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xioVer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40 CFL microscope and an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xioCa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R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5 (Carl Zeiss) after 14 days of incubation in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multi-</a:t>
            </a: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CFU medium.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uppieren 1"/>
          <p:cNvGrpSpPr/>
          <p:nvPr/>
        </p:nvGrpSpPr>
        <p:grpSpPr>
          <a:xfrm>
            <a:off x="33615" y="406695"/>
            <a:ext cx="5483617" cy="2841640"/>
            <a:chOff x="33615" y="406695"/>
            <a:chExt cx="5483617" cy="2841640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0049"/>
            <a:stretch/>
          </p:blipFill>
          <p:spPr bwMode="auto">
            <a:xfrm>
              <a:off x="1931733" y="1880613"/>
              <a:ext cx="1770394" cy="12671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" name="Gruppieren 4"/>
            <p:cNvGrpSpPr/>
            <p:nvPr/>
          </p:nvGrpSpPr>
          <p:grpSpPr>
            <a:xfrm>
              <a:off x="33615" y="406695"/>
              <a:ext cx="5483617" cy="2841640"/>
              <a:chOff x="329070" y="515857"/>
              <a:chExt cx="4390360" cy="2147810"/>
            </a:xfrm>
          </p:grpSpPr>
          <p:grpSp>
            <p:nvGrpSpPr>
              <p:cNvPr id="6" name="Gruppieren 5"/>
              <p:cNvGrpSpPr>
                <a:grpSpLocks noChangeAspect="1"/>
              </p:cNvGrpSpPr>
              <p:nvPr/>
            </p:nvGrpSpPr>
            <p:grpSpPr>
              <a:xfrm>
                <a:off x="395536" y="548680"/>
                <a:ext cx="4323894" cy="2114987"/>
                <a:chOff x="539552" y="332656"/>
                <a:chExt cx="11141006" cy="5449506"/>
              </a:xfrm>
            </p:grpSpPr>
            <p:pic>
              <p:nvPicPr>
                <p:cNvPr id="20" name="Picture 4" descr="C:\Users\L00661\Desktop\VIP Projekt\Versuche\Mikroskopie FLI\FLI Zellkulturmikroskop\CFUs von Tag 0 Versuch 32\CFU-GM1.jpg"/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10191"/>
                <a:stretch/>
              </p:blipFill>
              <p:spPr bwMode="auto">
                <a:xfrm>
                  <a:off x="8028383" y="3141519"/>
                  <a:ext cx="3633245" cy="244471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grpSp>
              <p:nvGrpSpPr>
                <p:cNvPr id="21" name="Gruppieren 20"/>
                <p:cNvGrpSpPr>
                  <a:grpSpLocks noChangeAspect="1"/>
                </p:cNvGrpSpPr>
                <p:nvPr/>
              </p:nvGrpSpPr>
              <p:grpSpPr>
                <a:xfrm>
                  <a:off x="539552" y="332656"/>
                  <a:ext cx="11141006" cy="5449506"/>
                  <a:chOff x="539552" y="332656"/>
                  <a:chExt cx="11141006" cy="5449506"/>
                </a:xfrm>
              </p:grpSpPr>
              <p:pic>
                <p:nvPicPr>
                  <p:cNvPr id="22" name="Picture 4" descr="C:\Users\L00661\Desktop\VIP Projekt\Versuche\Mikroskopie FLI\FLI Zellkulturmikroskop\CFUs von Tag 0 Versuch 32\BFU-E3.jp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5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6">
                            <a14:imgEffect>
                              <a14:sharpenSoften amoun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" b="8173"/>
                  <a:stretch/>
                </p:blipFill>
                <p:spPr bwMode="auto">
                  <a:xfrm>
                    <a:off x="539552" y="332656"/>
                    <a:ext cx="3652175" cy="251266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23" name="Textfeld 4"/>
                  <p:cNvSpPr txBox="1"/>
                  <p:nvPr/>
                </p:nvSpPr>
                <p:spPr>
                  <a:xfrm>
                    <a:off x="539552" y="2531333"/>
                    <a:ext cx="1152128" cy="47581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de-DE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FU-E</a:t>
                    </a:r>
                  </a:p>
                </p:txBody>
              </p:sp>
              <p:pic>
                <p:nvPicPr>
                  <p:cNvPr id="24" name="Picture 3" descr="C:\Users\L00661\Desktop\VIP Projekt\Versuche\Mikroskopie FLI\FLI Zellkulturmikroskop\CFUs von Tag 0 Versuch 32\CFU-GEMM1.jp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7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8">
                            <a14:imgEffect>
                              <a14:brightnessContrast contrast="-1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" b="8173"/>
                  <a:stretch/>
                </p:blipFill>
                <p:spPr bwMode="auto">
                  <a:xfrm>
                    <a:off x="4283966" y="332656"/>
                    <a:ext cx="3652175" cy="2512661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25" name="Textfeld 6"/>
                  <p:cNvSpPr txBox="1"/>
                  <p:nvPr/>
                </p:nvSpPr>
                <p:spPr>
                  <a:xfrm>
                    <a:off x="4283964" y="2531334"/>
                    <a:ext cx="1636151" cy="47581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de-DE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FU-GEMM</a:t>
                    </a:r>
                  </a:p>
                </p:txBody>
              </p:sp>
              <p:pic>
                <p:nvPicPr>
                  <p:cNvPr id="26" name="Picture 4" descr="C:\Users\L00661\Desktop\VIP Projekt\Versuche\Mikroskopie FLI\FLI Zellkulturmikroskop\CFUs von Tag 0 Versuch 32\CFU-E2.jp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" b="8173"/>
                  <a:stretch/>
                </p:blipFill>
                <p:spPr bwMode="auto">
                  <a:xfrm>
                    <a:off x="8028383" y="332656"/>
                    <a:ext cx="3652175" cy="251266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27" name="Textfeld 8"/>
                  <p:cNvSpPr txBox="1"/>
                  <p:nvPr/>
                </p:nvSpPr>
                <p:spPr>
                  <a:xfrm>
                    <a:off x="8028383" y="2562107"/>
                    <a:ext cx="1152128" cy="47581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de-DE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FU-E</a:t>
                    </a:r>
                  </a:p>
                </p:txBody>
              </p:sp>
              <p:sp>
                <p:nvSpPr>
                  <p:cNvPr id="29" name="Textfeld 10"/>
                  <p:cNvSpPr txBox="1"/>
                  <p:nvPr/>
                </p:nvSpPr>
                <p:spPr>
                  <a:xfrm>
                    <a:off x="4293699" y="5306348"/>
                    <a:ext cx="1152128" cy="47581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de-DE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FU-G</a:t>
                    </a:r>
                  </a:p>
                </p:txBody>
              </p:sp>
              <p:pic>
                <p:nvPicPr>
                  <p:cNvPr id="30" name="Picture 4" descr="C:\Users\L00661\Desktop\VIP Projekt\Versuche\Mikroskopie FLI\FLI Zellkulturmikroskop\CFUs von Tag 0 Versuch 32\CFU-M2.jp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9323"/>
                  <a:stretch/>
                </p:blipFill>
                <p:spPr bwMode="auto">
                  <a:xfrm>
                    <a:off x="539552" y="3134629"/>
                    <a:ext cx="3642443" cy="2474593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31" name="Textfeld 12"/>
                  <p:cNvSpPr txBox="1"/>
                  <p:nvPr/>
                </p:nvSpPr>
                <p:spPr>
                  <a:xfrm>
                    <a:off x="539552" y="5298745"/>
                    <a:ext cx="1152128" cy="47581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de-DE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FU-M</a:t>
                    </a:r>
                  </a:p>
                </p:txBody>
              </p:sp>
              <p:sp>
                <p:nvSpPr>
                  <p:cNvPr id="32" name="Textfeld 14"/>
                  <p:cNvSpPr txBox="1"/>
                  <p:nvPr/>
                </p:nvSpPr>
                <p:spPr>
                  <a:xfrm>
                    <a:off x="8028383" y="5284748"/>
                    <a:ext cx="1816622" cy="47581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de-DE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FU-GM</a:t>
                    </a:r>
                  </a:p>
                </p:txBody>
              </p:sp>
            </p:grpSp>
          </p:grpSp>
          <p:sp>
            <p:nvSpPr>
              <p:cNvPr id="7" name="Textfeld 21"/>
              <p:cNvSpPr txBox="1"/>
              <p:nvPr/>
            </p:nvSpPr>
            <p:spPr>
              <a:xfrm>
                <a:off x="344923" y="515857"/>
                <a:ext cx="4471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8" name="Textfeld 22"/>
              <p:cNvSpPr txBox="1"/>
              <p:nvPr/>
            </p:nvSpPr>
            <p:spPr>
              <a:xfrm>
                <a:off x="1790903" y="517450"/>
                <a:ext cx="4471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9" name="Textfeld 23"/>
              <p:cNvSpPr txBox="1"/>
              <p:nvPr/>
            </p:nvSpPr>
            <p:spPr>
              <a:xfrm>
                <a:off x="3234547" y="517450"/>
                <a:ext cx="4471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0" name="Textfeld 24"/>
              <p:cNvSpPr txBox="1"/>
              <p:nvPr/>
            </p:nvSpPr>
            <p:spPr>
              <a:xfrm>
                <a:off x="329070" y="1607276"/>
                <a:ext cx="4471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sp>
            <p:nvSpPr>
              <p:cNvPr id="11" name="Textfeld 25"/>
              <p:cNvSpPr txBox="1"/>
              <p:nvPr/>
            </p:nvSpPr>
            <p:spPr>
              <a:xfrm>
                <a:off x="1786221" y="1607276"/>
                <a:ext cx="4471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</a:p>
            </p:txBody>
          </p:sp>
          <p:sp>
            <p:nvSpPr>
              <p:cNvPr id="12" name="Textfeld 26"/>
              <p:cNvSpPr txBox="1"/>
              <p:nvPr/>
            </p:nvSpPr>
            <p:spPr>
              <a:xfrm>
                <a:off x="3234547" y="1608687"/>
                <a:ext cx="4471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</a:p>
            </p:txBody>
          </p:sp>
          <p:cxnSp>
            <p:nvCxnSpPr>
              <p:cNvPr id="13" name="Gerade Verbindung 12"/>
              <p:cNvCxnSpPr/>
              <p:nvPr/>
            </p:nvCxnSpPr>
            <p:spPr>
              <a:xfrm>
                <a:off x="1528907" y="1473924"/>
                <a:ext cx="21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Textfeld 30"/>
              <p:cNvSpPr txBox="1"/>
              <p:nvPr/>
            </p:nvSpPr>
            <p:spPr>
              <a:xfrm>
                <a:off x="1484160" y="1365072"/>
                <a:ext cx="44714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de-DE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40 µm</a:t>
                </a:r>
              </a:p>
            </p:txBody>
          </p:sp>
          <p:cxnSp>
            <p:nvCxnSpPr>
              <p:cNvPr id="15" name="Gerade Verbindung 14"/>
              <p:cNvCxnSpPr/>
              <p:nvPr/>
            </p:nvCxnSpPr>
            <p:spPr>
              <a:xfrm>
                <a:off x="2987824" y="1473924"/>
                <a:ext cx="21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" name="Gerade Verbindung 15"/>
              <p:cNvCxnSpPr/>
              <p:nvPr/>
            </p:nvCxnSpPr>
            <p:spPr>
              <a:xfrm>
                <a:off x="4427984" y="1473924"/>
                <a:ext cx="21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" name="Gerade Verbindung 16"/>
              <p:cNvCxnSpPr/>
              <p:nvPr/>
            </p:nvCxnSpPr>
            <p:spPr>
              <a:xfrm>
                <a:off x="4464077" y="2538981"/>
                <a:ext cx="21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" name="Gerade Verbindung 17"/>
              <p:cNvCxnSpPr/>
              <p:nvPr/>
            </p:nvCxnSpPr>
            <p:spPr>
              <a:xfrm>
                <a:off x="2987823" y="2553634"/>
                <a:ext cx="21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" name="Gerade Verbindung 18"/>
              <p:cNvCxnSpPr/>
              <p:nvPr/>
            </p:nvCxnSpPr>
            <p:spPr>
              <a:xfrm>
                <a:off x="1528907" y="2553634"/>
                <a:ext cx="21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33" name="Textfeld 32"/>
          <p:cNvSpPr txBox="1"/>
          <p:nvPr/>
        </p:nvSpPr>
        <p:spPr>
          <a:xfrm>
            <a:off x="0" y="0"/>
            <a:ext cx="20053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6</a:t>
            </a:r>
          </a:p>
        </p:txBody>
      </p:sp>
    </p:spTree>
    <p:extLst>
      <p:ext uri="{BB962C8B-B14F-4D97-AF65-F5344CB8AC3E}">
        <p14:creationId xmlns:p14="http://schemas.microsoft.com/office/powerpoint/2010/main" val="383089919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03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x-Blümel, Lisa</dc:creator>
  <cp:lastModifiedBy>Jayaseela</cp:lastModifiedBy>
  <cp:revision>605</cp:revision>
  <cp:lastPrinted>2019-07-22T14:46:21Z</cp:lastPrinted>
  <dcterms:created xsi:type="dcterms:W3CDTF">2018-07-30T07:38:54Z</dcterms:created>
  <dcterms:modified xsi:type="dcterms:W3CDTF">2020-06-12T14:47:29Z</dcterms:modified>
</cp:coreProperties>
</file>